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>
      <p:cViewPr>
        <p:scale>
          <a:sx n="99" d="100"/>
          <a:sy n="99" d="100"/>
        </p:scale>
        <p:origin x="2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7C956-A55A-4C57-877D-BA61211D86D7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AB814-187E-457F-99EB-FE2318FA5D12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2486025" y="4592001"/>
            <a:ext cx="8267700" cy="17045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buNone/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. 1.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ptimization of reaction conditions for the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q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an multiplex fluorescent quantitative PCR Assay. 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(A)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ptimal primers concentrations for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q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an multiplex fluorescence qPCR.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(B)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Optimal probe concentrations for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q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an multiplex fluorescence qPCR.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543" y="1866746"/>
            <a:ext cx="5994400" cy="2634767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5364" y="1781033"/>
            <a:ext cx="5866636" cy="272048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1519" b="2024"/>
          <a:stretch>
            <a:fillRect/>
          </a:stretch>
        </p:blipFill>
        <p:spPr bwMode="auto">
          <a:xfrm>
            <a:off x="528855" y="644207"/>
            <a:ext cx="5567145" cy="2403793"/>
          </a:xfrm>
          <a:prstGeom prst="rect">
            <a:avLst/>
          </a:prstGeom>
          <a:ln>
            <a:noFill/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/>
          <a:srcRect l="1075" r="1" b="2860"/>
          <a:stretch>
            <a:fillRect/>
          </a:stretch>
        </p:blipFill>
        <p:spPr bwMode="auto">
          <a:xfrm>
            <a:off x="6159042" y="644207"/>
            <a:ext cx="5504103" cy="2403793"/>
          </a:xfrm>
          <a:prstGeom prst="rect">
            <a:avLst/>
          </a:prstGeom>
          <a:ln>
            <a:noFill/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4"/>
          <a:srcRect l="1090" b="2654"/>
          <a:stretch>
            <a:fillRect/>
          </a:stretch>
        </p:blipFill>
        <p:spPr bwMode="auto">
          <a:xfrm>
            <a:off x="528855" y="3429000"/>
            <a:ext cx="5567568" cy="2514600"/>
          </a:xfrm>
          <a:prstGeom prst="rect">
            <a:avLst/>
          </a:prstGeom>
          <a:ln>
            <a:noFill/>
          </a:ln>
        </p:spPr>
      </p:pic>
      <p:sp>
        <p:nvSpPr>
          <p:cNvPr id="8" name="文本框 7"/>
          <p:cNvSpPr txBox="1"/>
          <p:nvPr/>
        </p:nvSpPr>
        <p:spPr>
          <a:xfrm>
            <a:off x="6329145" y="3810001"/>
            <a:ext cx="5862855" cy="17104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266700" algn="ctr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2.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ptimization of annealing temperature for the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q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n-MGB multiplex fluorescence qPCR assay. 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annealing temperature is 60 </a:t>
            </a:r>
            <a:r>
              <a:rPr lang="zh-CN" altLang="zh-CN" sz="1800" kern="1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B)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annealing temperature is 62 </a:t>
            </a:r>
            <a:r>
              <a:rPr lang="zh-CN" altLang="zh-CN" sz="1800" kern="1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)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annealing temperature is 64 </a:t>
            </a:r>
            <a:r>
              <a:rPr lang="zh-CN" altLang="zh-CN" sz="1800" kern="1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℃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2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907" r="-1" b="3002"/>
          <a:stretch>
            <a:fillRect/>
          </a:stretch>
        </p:blipFill>
        <p:spPr bwMode="auto">
          <a:xfrm>
            <a:off x="2663440" y="603884"/>
            <a:ext cx="6865119" cy="3015615"/>
          </a:xfrm>
          <a:prstGeom prst="rect">
            <a:avLst/>
          </a:prstGeom>
          <a:ln>
            <a:noFill/>
          </a:ln>
        </p:spPr>
      </p:pic>
      <p:sp>
        <p:nvSpPr>
          <p:cNvPr id="4" name="文本框 3"/>
          <p:cNvSpPr txBox="1"/>
          <p:nvPr/>
        </p:nvSpPr>
        <p:spPr>
          <a:xfrm>
            <a:off x="1709736" y="3819012"/>
            <a:ext cx="8772525" cy="29569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266700" algn="ctr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zh-CN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3. 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pecificity test of the 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q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n multiplex fluorescent quantitative PCR Assay. The DNA of other pathogens unrelated to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ryptosporidium, Giardia, E. </a:t>
            </a:r>
            <a:r>
              <a:rPr lang="en-US" altLang="zh-CN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ieneusi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as used as a template. Other pathogens include 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imeria; </a:t>
            </a:r>
            <a:r>
              <a:rPr lang="en-US" altLang="zh-CN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oniezia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H. </a:t>
            </a:r>
            <a:r>
              <a:rPr lang="en-US" altLang="zh-CN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tortus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. asperum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. monocytogenes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E. coli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;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. aureus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The results showed that fluorescence signals could be detected for the three pathogens labeled with VIC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yptosporidium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, FAM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iardia lamblia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, and CY5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. </a:t>
            </a:r>
            <a:r>
              <a:rPr lang="en-US" altLang="zh-CN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ieneusi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respectively. However, for the other pathogens, there was no amplification curve, which was the same as that of the negative control. </a:t>
            </a:r>
            <a:endParaRPr lang="zh-CN" alt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370" y="201196"/>
            <a:ext cx="5105350" cy="2241374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42468" y="4971460"/>
            <a:ext cx="11582820" cy="15799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266700" algn="ctr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4.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Sensitivity test of the 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aq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an multiplex fluorescent quantitative PCR Assay. 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results of the sensitivity amplification curves of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yptosporidium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the plasmid concentrations of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yptosporidium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2.983</a:t>
            </a:r>
            <a:r>
              <a:rPr lang="zh-CN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to 2.983</a:t>
            </a:r>
            <a:r>
              <a:rPr lang="zh-CN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. (B) The results of the sensitivity amplification curves of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iardia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the plasmid concentrations of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iardia lamblia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ere 3.933</a:t>
            </a:r>
            <a:r>
              <a:rPr lang="zh-CN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to 3.933</a:t>
            </a:r>
            <a:r>
              <a:rPr lang="zh-CN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.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results of the sensitivity amplification curves of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ieneusi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the plasmid concentrations of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ieneusi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3.315</a:t>
            </a:r>
            <a:r>
              <a:rPr lang="zh-CN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to 3.315</a:t>
            </a:r>
            <a:r>
              <a:rPr lang="zh-CN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2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. 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results of the sensitivity amplification curves of three pathogens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negative control was set up in each group of the assay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570" y="2601136"/>
            <a:ext cx="5106722" cy="2241373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782955" y="2731050"/>
            <a:ext cx="4064000" cy="306705"/>
          </a:xfrm>
          <a:prstGeom prst="rect">
            <a:avLst/>
          </a:prstGeom>
        </p:spPr>
        <p:txBody>
          <a:bodyPr>
            <a:spAutoFit/>
            <a:extLst>
              <a:ext uri="{4A0BC546-FE56-4ADE-93B0-CB8AF2F6F144}">
                <wpsdc:textFrameExt xmlns:wpsdc="http://www.wps.cn/officeDocument/2022/drawingmlCustomData" xmlns="" type="text"/>
              </a:ext>
            </a:extLst>
          </a:bodyPr>
          <a:lstStyle/>
          <a:p>
            <a:pPr algn="l"/>
            <a:r>
              <a:rPr lang="en-US" altLang="zh-CN" sz="1400" b="1">
                <a:latin typeface="Times New Roman" panose="02020603050405020304" pitchFamily="18" charset="0"/>
                <a:ea typeface="微软雅黑" panose="020B0503020204020204" charset="-122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DE54C0CD-8323-ABB7-C3EA-8E33294FEA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80970" y="2601135"/>
            <a:ext cx="5105350" cy="231200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BAF1B063-2876-8AA4-9A03-2BC1D3ACD8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80970" y="130567"/>
            <a:ext cx="5105350" cy="2312003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417528" y="4918754"/>
            <a:ext cx="11506200" cy="16332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266700" algn="ctr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zh-CN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</a:t>
            </a:r>
            <a:r>
              <a:rPr lang="en-US" altLang="zh-CN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5.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tandard Curves for the </a:t>
            </a:r>
            <a:r>
              <a:rPr lang="en-US" altLang="zh-CN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q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n multiplex fluorescent quantitative PCR Assay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indent="266700" algn="ctr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quantified DNA plasmid of </a:t>
            </a:r>
            <a:r>
              <a:rPr lang="en-US" altLang="zh-CN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ryptosporidium, Giardia lamblia and E. </a:t>
            </a:r>
            <a:r>
              <a:rPr lang="en-US" altLang="zh-CN" sz="16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ieneusi</a:t>
            </a:r>
            <a:r>
              <a:rPr lang="en-US" altLang="zh-CN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centrations of 2.983</a:t>
            </a:r>
            <a:r>
              <a:rPr lang="zh-CN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to 2.983</a:t>
            </a:r>
            <a:r>
              <a:rPr lang="zh-CN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, 3.933</a:t>
            </a:r>
            <a:r>
              <a:rPr lang="zh-CN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to 3.933</a:t>
            </a:r>
            <a:r>
              <a:rPr lang="zh-CN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and 3.315</a:t>
            </a:r>
            <a:r>
              <a:rPr lang="zh-CN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to 3.315</a:t>
            </a:r>
            <a:r>
              <a:rPr lang="zh-CN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6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pies respectively, employed as a positive control respectively, was diluted three times in 10-fold serial dilutions, and the examination of these three replicates produced the curve.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60606"/>
            <a:ext cx="3886200" cy="2781493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9355" y="1264652"/>
            <a:ext cx="4040416" cy="2905263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9771" y="1122612"/>
            <a:ext cx="4213957" cy="3019487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5081" y="1167447"/>
            <a:ext cx="7121837" cy="3166428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733550" y="4572215"/>
            <a:ext cx="8553450" cy="8794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266700" algn="ctr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6.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result of partial clinical samples test of multiplex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q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n qPCR for three zoonotic gastrointestinal protozoa in dairy goat. </a:t>
            </a:r>
            <a:endParaRPr lang="zh-CN" altLang="zh-CN" sz="20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454</Words>
  <Application>Microsoft Office PowerPoint</Application>
  <PresentationFormat>宽屏</PresentationFormat>
  <Paragraphs>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等线</vt:lpstr>
      <vt:lpstr>等线 Light</vt:lpstr>
      <vt:lpstr>Arial</vt:lpstr>
      <vt:lpstr>Segoe U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敬睿 刘</dc:creator>
  <cp:lastModifiedBy>敬睿 刘</cp:lastModifiedBy>
  <cp:revision>4</cp:revision>
  <dcterms:created xsi:type="dcterms:W3CDTF">2025-08-06T09:28:00Z</dcterms:created>
  <dcterms:modified xsi:type="dcterms:W3CDTF">2025-09-12T08:30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A566EA1A988462FA79B9EFB04A58C25_12</vt:lpwstr>
  </property>
  <property fmtid="{D5CDD505-2E9C-101B-9397-08002B2CF9AE}" pid="3" name="KSOProductBuildVer">
    <vt:lpwstr>2052-12.1.0.22529</vt:lpwstr>
  </property>
</Properties>
</file>